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96" y="-17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\Documents\WorkFolder\Data\Bacteria-specific%20T%20cell%20response\&#45936;&#51060;&#53552;&#53685;&#54633;&#48516;&#49437;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ko-KR"/>
  <c:chart>
    <c:plotArea>
      <c:layout>
        <c:manualLayout>
          <c:layoutTarget val="inner"/>
          <c:xMode val="edge"/>
          <c:yMode val="edge"/>
          <c:x val="0.12816536408785301"/>
          <c:y val="4.3170020414114905E-2"/>
          <c:w val="0.85079589029066915"/>
          <c:h val="0.89719889180519263"/>
        </c:manualLayout>
      </c:layout>
      <c:scatterChart>
        <c:scatterStyle val="lineMarker"/>
        <c:ser>
          <c:idx val="0"/>
          <c:order val="0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cytokine!$C$1:$U$1</c:f>
              <c:strCache>
                <c:ptCount val="19"/>
                <c:pt idx="0">
                  <c:v>Basal-IFNg</c:v>
                </c:pt>
                <c:pt idx="1">
                  <c:v>Fn-IFNg</c:v>
                </c:pt>
                <c:pt idx="2">
                  <c:v>Td-IFNg</c:v>
                </c:pt>
                <c:pt idx="3">
                  <c:v>TT-IFNg</c:v>
                </c:pt>
                <c:pt idx="5">
                  <c:v>Basal-IL4</c:v>
                </c:pt>
                <c:pt idx="6">
                  <c:v>Fn-IL4</c:v>
                </c:pt>
                <c:pt idx="7">
                  <c:v>Td-IL4</c:v>
                </c:pt>
                <c:pt idx="8">
                  <c:v>TT-IL4</c:v>
                </c:pt>
                <c:pt idx="10">
                  <c:v>Basal-IL10</c:v>
                </c:pt>
                <c:pt idx="11">
                  <c:v>Fn-IL10</c:v>
                </c:pt>
                <c:pt idx="12">
                  <c:v>Td-IL10</c:v>
                </c:pt>
                <c:pt idx="13">
                  <c:v>TT-IL10</c:v>
                </c:pt>
                <c:pt idx="15">
                  <c:v>Basal-IL17</c:v>
                </c:pt>
                <c:pt idx="16">
                  <c:v>Fn-IL17</c:v>
                </c:pt>
                <c:pt idx="17">
                  <c:v>Td-IL17</c:v>
                </c:pt>
                <c:pt idx="18">
                  <c:v>TT-IL17</c:v>
                </c:pt>
              </c:strCache>
            </c:strRef>
          </c:xVal>
          <c:yVal>
            <c:numRef>
              <c:f>cytokine!$C$2:$U$2</c:f>
              <c:numCache>
                <c:formatCode>0.0_ </c:formatCode>
                <c:ptCount val="19"/>
                <c:pt idx="0">
                  <c:v>0</c:v>
                </c:pt>
                <c:pt idx="1">
                  <c:v>526.00000000000011</c:v>
                </c:pt>
                <c:pt idx="2">
                  <c:v>1150.5</c:v>
                </c:pt>
                <c:pt idx="3">
                  <c:v>1831</c:v>
                </c:pt>
                <c:pt idx="5">
                  <c:v>0.82142857142857351</c:v>
                </c:pt>
                <c:pt idx="6">
                  <c:v>0.214285714285713</c:v>
                </c:pt>
                <c:pt idx="7">
                  <c:v>1.0000000000000005E-2</c:v>
                </c:pt>
                <c:pt idx="8">
                  <c:v>1.0000000000000005E-2</c:v>
                </c:pt>
                <c:pt idx="10">
                  <c:v>7.5000000000000426</c:v>
                </c:pt>
                <c:pt idx="11">
                  <c:v>8542.9166666666188</c:v>
                </c:pt>
                <c:pt idx="12">
                  <c:v>7021.6666666667161</c:v>
                </c:pt>
                <c:pt idx="13">
                  <c:v>7218.3333333333276</c:v>
                </c:pt>
                <c:pt idx="15">
                  <c:v>47.192307692307857</c:v>
                </c:pt>
                <c:pt idx="16">
                  <c:v>45.000000000000007</c:v>
                </c:pt>
                <c:pt idx="17">
                  <c:v>165.57692307692321</c:v>
                </c:pt>
                <c:pt idx="18">
                  <c:v>229.96153846153851</c:v>
                </c:pt>
              </c:numCache>
            </c:numRef>
          </c:yVal>
        </c:ser>
        <c:ser>
          <c:idx val="1"/>
          <c:order val="1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cytokine!$C$1:$U$1</c:f>
              <c:strCache>
                <c:ptCount val="19"/>
                <c:pt idx="0">
                  <c:v>Basal-IFNg</c:v>
                </c:pt>
                <c:pt idx="1">
                  <c:v>Fn-IFNg</c:v>
                </c:pt>
                <c:pt idx="2">
                  <c:v>Td-IFNg</c:v>
                </c:pt>
                <c:pt idx="3">
                  <c:v>TT-IFNg</c:v>
                </c:pt>
                <c:pt idx="5">
                  <c:v>Basal-IL4</c:v>
                </c:pt>
                <c:pt idx="6">
                  <c:v>Fn-IL4</c:v>
                </c:pt>
                <c:pt idx="7">
                  <c:v>Td-IL4</c:v>
                </c:pt>
                <c:pt idx="8">
                  <c:v>TT-IL4</c:v>
                </c:pt>
                <c:pt idx="10">
                  <c:v>Basal-IL10</c:v>
                </c:pt>
                <c:pt idx="11">
                  <c:v>Fn-IL10</c:v>
                </c:pt>
                <c:pt idx="12">
                  <c:v>Td-IL10</c:v>
                </c:pt>
                <c:pt idx="13">
                  <c:v>TT-IL10</c:v>
                </c:pt>
                <c:pt idx="15">
                  <c:v>Basal-IL17</c:v>
                </c:pt>
                <c:pt idx="16">
                  <c:v>Fn-IL17</c:v>
                </c:pt>
                <c:pt idx="17">
                  <c:v>Td-IL17</c:v>
                </c:pt>
                <c:pt idx="18">
                  <c:v>TT-IL17</c:v>
                </c:pt>
              </c:strCache>
            </c:strRef>
          </c:xVal>
          <c:yVal>
            <c:numRef>
              <c:f>cytokine!$C$3:$U$3</c:f>
              <c:numCache>
                <c:formatCode>0.0_ </c:formatCode>
                <c:ptCount val="19"/>
                <c:pt idx="0">
                  <c:v>29</c:v>
                </c:pt>
                <c:pt idx="1">
                  <c:v>550</c:v>
                </c:pt>
                <c:pt idx="2">
                  <c:v>1358</c:v>
                </c:pt>
                <c:pt idx="3">
                  <c:v>7120</c:v>
                </c:pt>
                <c:pt idx="5">
                  <c:v>0.53571428571428359</c:v>
                </c:pt>
                <c:pt idx="6">
                  <c:v>0.14285714285714268</c:v>
                </c:pt>
                <c:pt idx="7">
                  <c:v>1.0000000000000005E-2</c:v>
                </c:pt>
                <c:pt idx="8">
                  <c:v>1.0000000000000005E-2</c:v>
                </c:pt>
                <c:pt idx="10">
                  <c:v>437.08333333333348</c:v>
                </c:pt>
                <c:pt idx="11">
                  <c:v>4571.6666666667161</c:v>
                </c:pt>
                <c:pt idx="12">
                  <c:v>4564.1666666667161</c:v>
                </c:pt>
                <c:pt idx="13">
                  <c:v>4854.5833333333276</c:v>
                </c:pt>
                <c:pt idx="15">
                  <c:v>348.69230769230768</c:v>
                </c:pt>
                <c:pt idx="16">
                  <c:v>108.3461538461539</c:v>
                </c:pt>
                <c:pt idx="17">
                  <c:v>151.61538461538458</c:v>
                </c:pt>
                <c:pt idx="18">
                  <c:v>239.07692307692321</c:v>
                </c:pt>
              </c:numCache>
            </c:numRef>
          </c:yVal>
        </c:ser>
        <c:ser>
          <c:idx val="2"/>
          <c:order val="2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cytokine!$C$1:$U$1</c:f>
              <c:strCache>
                <c:ptCount val="19"/>
                <c:pt idx="0">
                  <c:v>Basal-IFNg</c:v>
                </c:pt>
                <c:pt idx="1">
                  <c:v>Fn-IFNg</c:v>
                </c:pt>
                <c:pt idx="2">
                  <c:v>Td-IFNg</c:v>
                </c:pt>
                <c:pt idx="3">
                  <c:v>TT-IFNg</c:v>
                </c:pt>
                <c:pt idx="5">
                  <c:v>Basal-IL4</c:v>
                </c:pt>
                <c:pt idx="6">
                  <c:v>Fn-IL4</c:v>
                </c:pt>
                <c:pt idx="7">
                  <c:v>Td-IL4</c:v>
                </c:pt>
                <c:pt idx="8">
                  <c:v>TT-IL4</c:v>
                </c:pt>
                <c:pt idx="10">
                  <c:v>Basal-IL10</c:v>
                </c:pt>
                <c:pt idx="11">
                  <c:v>Fn-IL10</c:v>
                </c:pt>
                <c:pt idx="12">
                  <c:v>Td-IL10</c:v>
                </c:pt>
                <c:pt idx="13">
                  <c:v>TT-IL10</c:v>
                </c:pt>
                <c:pt idx="15">
                  <c:v>Basal-IL17</c:v>
                </c:pt>
                <c:pt idx="16">
                  <c:v>Fn-IL17</c:v>
                </c:pt>
                <c:pt idx="17">
                  <c:v>Td-IL17</c:v>
                </c:pt>
                <c:pt idx="18">
                  <c:v>TT-IL17</c:v>
                </c:pt>
              </c:strCache>
            </c:strRef>
          </c:xVal>
          <c:yVal>
            <c:numRef>
              <c:f>cytokine!$C$4:$U$4</c:f>
              <c:numCache>
                <c:formatCode>0.0_ </c:formatCode>
                <c:ptCount val="19"/>
                <c:pt idx="0">
                  <c:v>91.6</c:v>
                </c:pt>
                <c:pt idx="1">
                  <c:v>119.2</c:v>
                </c:pt>
                <c:pt idx="2">
                  <c:v>670.2</c:v>
                </c:pt>
                <c:pt idx="3">
                  <c:v>3357.8</c:v>
                </c:pt>
                <c:pt idx="5">
                  <c:v>0.3214285714285729</c:v>
                </c:pt>
                <c:pt idx="6">
                  <c:v>1.0000000000000005E-2</c:v>
                </c:pt>
                <c:pt idx="7">
                  <c:v>1.0000000000000005E-2</c:v>
                </c:pt>
                <c:pt idx="8">
                  <c:v>1.0000000000000005E-2</c:v>
                </c:pt>
                <c:pt idx="10">
                  <c:v>165.00000000000011</c:v>
                </c:pt>
                <c:pt idx="11">
                  <c:v>2321.6666666666461</c:v>
                </c:pt>
                <c:pt idx="12">
                  <c:v>2878.3333333333644</c:v>
                </c:pt>
                <c:pt idx="13">
                  <c:v>3347.9166666666647</c:v>
                </c:pt>
                <c:pt idx="15">
                  <c:v>321.88235294117351</c:v>
                </c:pt>
                <c:pt idx="16">
                  <c:v>330.35294117647072</c:v>
                </c:pt>
                <c:pt idx="17">
                  <c:v>470.17647058823519</c:v>
                </c:pt>
                <c:pt idx="18">
                  <c:v>457.11764705882371</c:v>
                </c:pt>
              </c:numCache>
            </c:numRef>
          </c:yVal>
        </c:ser>
        <c:ser>
          <c:idx val="3"/>
          <c:order val="3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cytokine!$C$1:$U$1</c:f>
              <c:strCache>
                <c:ptCount val="19"/>
                <c:pt idx="0">
                  <c:v>Basal-IFNg</c:v>
                </c:pt>
                <c:pt idx="1">
                  <c:v>Fn-IFNg</c:v>
                </c:pt>
                <c:pt idx="2">
                  <c:v>Td-IFNg</c:v>
                </c:pt>
                <c:pt idx="3">
                  <c:v>TT-IFNg</c:v>
                </c:pt>
                <c:pt idx="5">
                  <c:v>Basal-IL4</c:v>
                </c:pt>
                <c:pt idx="6">
                  <c:v>Fn-IL4</c:v>
                </c:pt>
                <c:pt idx="7">
                  <c:v>Td-IL4</c:v>
                </c:pt>
                <c:pt idx="8">
                  <c:v>TT-IL4</c:v>
                </c:pt>
                <c:pt idx="10">
                  <c:v>Basal-IL10</c:v>
                </c:pt>
                <c:pt idx="11">
                  <c:v>Fn-IL10</c:v>
                </c:pt>
                <c:pt idx="12">
                  <c:v>Td-IL10</c:v>
                </c:pt>
                <c:pt idx="13">
                  <c:v>TT-IL10</c:v>
                </c:pt>
                <c:pt idx="15">
                  <c:v>Basal-IL17</c:v>
                </c:pt>
                <c:pt idx="16">
                  <c:v>Fn-IL17</c:v>
                </c:pt>
                <c:pt idx="17">
                  <c:v>Td-IL17</c:v>
                </c:pt>
                <c:pt idx="18">
                  <c:v>TT-IL17</c:v>
                </c:pt>
              </c:strCache>
            </c:strRef>
          </c:xVal>
          <c:yVal>
            <c:numRef>
              <c:f>cytokine!$C$5:$U$5</c:f>
              <c:numCache>
                <c:formatCode>0.0_ </c:formatCode>
                <c:ptCount val="19"/>
                <c:pt idx="0">
                  <c:v>146</c:v>
                </c:pt>
                <c:pt idx="1">
                  <c:v>118.33333333333299</c:v>
                </c:pt>
                <c:pt idx="2">
                  <c:v>141.33333333333394</c:v>
                </c:pt>
                <c:pt idx="3">
                  <c:v>1090.3333333333251</c:v>
                </c:pt>
                <c:pt idx="5">
                  <c:v>0.89285714285714057</c:v>
                </c:pt>
                <c:pt idx="6">
                  <c:v>1.0000000000000005E-2</c:v>
                </c:pt>
                <c:pt idx="7">
                  <c:v>0.107142857142855</c:v>
                </c:pt>
                <c:pt idx="8">
                  <c:v>0.42857142857142799</c:v>
                </c:pt>
                <c:pt idx="10">
                  <c:v>1483.75</c:v>
                </c:pt>
                <c:pt idx="11">
                  <c:v>9282.5</c:v>
                </c:pt>
                <c:pt idx="12">
                  <c:v>12402.5</c:v>
                </c:pt>
                <c:pt idx="13">
                  <c:v>10521.25</c:v>
                </c:pt>
                <c:pt idx="15">
                  <c:v>113.23404255319119</c:v>
                </c:pt>
                <c:pt idx="16">
                  <c:v>194.12765957446749</c:v>
                </c:pt>
                <c:pt idx="17">
                  <c:v>196.46808510638272</c:v>
                </c:pt>
                <c:pt idx="18">
                  <c:v>283.872340425532</c:v>
                </c:pt>
              </c:numCache>
            </c:numRef>
          </c:yVal>
        </c:ser>
        <c:ser>
          <c:idx val="4"/>
          <c:order val="4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cytokine!$C$1:$U$1</c:f>
              <c:strCache>
                <c:ptCount val="19"/>
                <c:pt idx="0">
                  <c:v>Basal-IFNg</c:v>
                </c:pt>
                <c:pt idx="1">
                  <c:v>Fn-IFNg</c:v>
                </c:pt>
                <c:pt idx="2">
                  <c:v>Td-IFNg</c:v>
                </c:pt>
                <c:pt idx="3">
                  <c:v>TT-IFNg</c:v>
                </c:pt>
                <c:pt idx="5">
                  <c:v>Basal-IL4</c:v>
                </c:pt>
                <c:pt idx="6">
                  <c:v>Fn-IL4</c:v>
                </c:pt>
                <c:pt idx="7">
                  <c:v>Td-IL4</c:v>
                </c:pt>
                <c:pt idx="8">
                  <c:v>TT-IL4</c:v>
                </c:pt>
                <c:pt idx="10">
                  <c:v>Basal-IL10</c:v>
                </c:pt>
                <c:pt idx="11">
                  <c:v>Fn-IL10</c:v>
                </c:pt>
                <c:pt idx="12">
                  <c:v>Td-IL10</c:v>
                </c:pt>
                <c:pt idx="13">
                  <c:v>TT-IL10</c:v>
                </c:pt>
                <c:pt idx="15">
                  <c:v>Basal-IL17</c:v>
                </c:pt>
                <c:pt idx="16">
                  <c:v>Fn-IL17</c:v>
                </c:pt>
                <c:pt idx="17">
                  <c:v>Td-IL17</c:v>
                </c:pt>
                <c:pt idx="18">
                  <c:v>TT-IL17</c:v>
                </c:pt>
              </c:strCache>
            </c:strRef>
          </c:xVal>
          <c:yVal>
            <c:numRef>
              <c:f>cytokine!$C$6:$U$6</c:f>
              <c:numCache>
                <c:formatCode>0.0_ </c:formatCode>
                <c:ptCount val="19"/>
                <c:pt idx="0">
                  <c:v>40.20000000000001</c:v>
                </c:pt>
                <c:pt idx="1">
                  <c:v>37.4</c:v>
                </c:pt>
                <c:pt idx="2">
                  <c:v>52.4</c:v>
                </c:pt>
                <c:pt idx="3">
                  <c:v>52.600000000000009</c:v>
                </c:pt>
                <c:pt idx="10">
                  <c:v>1.0000000000000005E-2</c:v>
                </c:pt>
                <c:pt idx="11">
                  <c:v>1.0000000000000005E-2</c:v>
                </c:pt>
                <c:pt idx="12">
                  <c:v>1.0000000000000005E-2</c:v>
                </c:pt>
                <c:pt idx="13">
                  <c:v>12.500000000000012</c:v>
                </c:pt>
                <c:pt idx="15">
                  <c:v>32.117647058823195</c:v>
                </c:pt>
                <c:pt idx="16">
                  <c:v>15.529411764705888</c:v>
                </c:pt>
                <c:pt idx="17">
                  <c:v>18.764705882352889</c:v>
                </c:pt>
                <c:pt idx="18">
                  <c:v>45.176470588235297</c:v>
                </c:pt>
              </c:numCache>
            </c:numRef>
          </c:yVal>
        </c:ser>
        <c:ser>
          <c:idx val="5"/>
          <c:order val="5"/>
          <c:spPr>
            <a:ln w="28575">
              <a:noFill/>
            </a:ln>
          </c:spPr>
          <c:marker>
            <c:symbol val="circle"/>
            <c:size val="7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xVal>
            <c:strRef>
              <c:f>cytokine!$C$1:$U$1</c:f>
              <c:strCache>
                <c:ptCount val="19"/>
                <c:pt idx="0">
                  <c:v>Basal-IFNg</c:v>
                </c:pt>
                <c:pt idx="1">
                  <c:v>Fn-IFNg</c:v>
                </c:pt>
                <c:pt idx="2">
                  <c:v>Td-IFNg</c:v>
                </c:pt>
                <c:pt idx="3">
                  <c:v>TT-IFNg</c:v>
                </c:pt>
                <c:pt idx="5">
                  <c:v>Basal-IL4</c:v>
                </c:pt>
                <c:pt idx="6">
                  <c:v>Fn-IL4</c:v>
                </c:pt>
                <c:pt idx="7">
                  <c:v>Td-IL4</c:v>
                </c:pt>
                <c:pt idx="8">
                  <c:v>TT-IL4</c:v>
                </c:pt>
                <c:pt idx="10">
                  <c:v>Basal-IL10</c:v>
                </c:pt>
                <c:pt idx="11">
                  <c:v>Fn-IL10</c:v>
                </c:pt>
                <c:pt idx="12">
                  <c:v>Td-IL10</c:v>
                </c:pt>
                <c:pt idx="13">
                  <c:v>TT-IL10</c:v>
                </c:pt>
                <c:pt idx="15">
                  <c:v>Basal-IL17</c:v>
                </c:pt>
                <c:pt idx="16">
                  <c:v>Fn-IL17</c:v>
                </c:pt>
                <c:pt idx="17">
                  <c:v>Td-IL17</c:v>
                </c:pt>
                <c:pt idx="18">
                  <c:v>TT-IL17</c:v>
                </c:pt>
              </c:strCache>
            </c:strRef>
          </c:xVal>
          <c:yVal>
            <c:numRef>
              <c:f>cytokine!$C$7:$U$7</c:f>
              <c:numCache>
                <c:formatCode>General</c:formatCode>
                <c:ptCount val="19"/>
              </c:numCache>
            </c:numRef>
          </c:yVal>
        </c:ser>
        <c:ser>
          <c:idx val="6"/>
          <c:order val="6"/>
          <c:spPr>
            <a:ln w="28575">
              <a:noFill/>
            </a:ln>
          </c:spPr>
          <c:xVal>
            <c:strRef>
              <c:f>cytokine!$C$1:$U$1</c:f>
              <c:strCache>
                <c:ptCount val="19"/>
                <c:pt idx="0">
                  <c:v>Basal-IFNg</c:v>
                </c:pt>
                <c:pt idx="1">
                  <c:v>Fn-IFNg</c:v>
                </c:pt>
                <c:pt idx="2">
                  <c:v>Td-IFNg</c:v>
                </c:pt>
                <c:pt idx="3">
                  <c:v>TT-IFNg</c:v>
                </c:pt>
                <c:pt idx="5">
                  <c:v>Basal-IL4</c:v>
                </c:pt>
                <c:pt idx="6">
                  <c:v>Fn-IL4</c:v>
                </c:pt>
                <c:pt idx="7">
                  <c:v>Td-IL4</c:v>
                </c:pt>
                <c:pt idx="8">
                  <c:v>TT-IL4</c:v>
                </c:pt>
                <c:pt idx="10">
                  <c:v>Basal-IL10</c:v>
                </c:pt>
                <c:pt idx="11">
                  <c:v>Fn-IL10</c:v>
                </c:pt>
                <c:pt idx="12">
                  <c:v>Td-IL10</c:v>
                </c:pt>
                <c:pt idx="13">
                  <c:v>TT-IL10</c:v>
                </c:pt>
                <c:pt idx="15">
                  <c:v>Basal-IL17</c:v>
                </c:pt>
                <c:pt idx="16">
                  <c:v>Fn-IL17</c:v>
                </c:pt>
                <c:pt idx="17">
                  <c:v>Td-IL17</c:v>
                </c:pt>
                <c:pt idx="18">
                  <c:v>TT-IL17</c:v>
                </c:pt>
              </c:strCache>
            </c:strRef>
          </c:xVal>
          <c:yVal>
            <c:numRef>
              <c:f>cytokine!$C$8:$U$8</c:f>
              <c:numCache>
                <c:formatCode>General</c:formatCode>
                <c:ptCount val="19"/>
              </c:numCache>
            </c:numRef>
          </c:yVal>
        </c:ser>
        <c:ser>
          <c:idx val="7"/>
          <c:order val="7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cytokine!$C$1:$U$1</c:f>
              <c:strCache>
                <c:ptCount val="19"/>
                <c:pt idx="0">
                  <c:v>Basal-IFNg</c:v>
                </c:pt>
                <c:pt idx="1">
                  <c:v>Fn-IFNg</c:v>
                </c:pt>
                <c:pt idx="2">
                  <c:v>Td-IFNg</c:v>
                </c:pt>
                <c:pt idx="3">
                  <c:v>TT-IFNg</c:v>
                </c:pt>
                <c:pt idx="5">
                  <c:v>Basal-IL4</c:v>
                </c:pt>
                <c:pt idx="6">
                  <c:v>Fn-IL4</c:v>
                </c:pt>
                <c:pt idx="7">
                  <c:v>Td-IL4</c:v>
                </c:pt>
                <c:pt idx="8">
                  <c:v>TT-IL4</c:v>
                </c:pt>
                <c:pt idx="10">
                  <c:v>Basal-IL10</c:v>
                </c:pt>
                <c:pt idx="11">
                  <c:v>Fn-IL10</c:v>
                </c:pt>
                <c:pt idx="12">
                  <c:v>Td-IL10</c:v>
                </c:pt>
                <c:pt idx="13">
                  <c:v>TT-IL10</c:v>
                </c:pt>
                <c:pt idx="15">
                  <c:v>Basal-IL17</c:v>
                </c:pt>
                <c:pt idx="16">
                  <c:v>Fn-IL17</c:v>
                </c:pt>
                <c:pt idx="17">
                  <c:v>Td-IL17</c:v>
                </c:pt>
                <c:pt idx="18">
                  <c:v>TT-IL17</c:v>
                </c:pt>
              </c:strCache>
            </c:strRef>
          </c:xVal>
          <c:yVal>
            <c:numRef>
              <c:f>cytokine!$C$9:$U$9</c:f>
              <c:numCache>
                <c:formatCode>0.0_ </c:formatCode>
                <c:ptCount val="19"/>
                <c:pt idx="0">
                  <c:v>99.000000000000028</c:v>
                </c:pt>
                <c:pt idx="1">
                  <c:v>170</c:v>
                </c:pt>
                <c:pt idx="2">
                  <c:v>283</c:v>
                </c:pt>
                <c:pt idx="3">
                  <c:v>316.33333333333331</c:v>
                </c:pt>
                <c:pt idx="5">
                  <c:v>0.57142857142857451</c:v>
                </c:pt>
                <c:pt idx="6">
                  <c:v>0.28571428571428525</c:v>
                </c:pt>
                <c:pt idx="7">
                  <c:v>0.17857142857142777</c:v>
                </c:pt>
                <c:pt idx="8">
                  <c:v>0.28571428571428525</c:v>
                </c:pt>
                <c:pt idx="10">
                  <c:v>2225</c:v>
                </c:pt>
                <c:pt idx="11">
                  <c:v>5110.8333333333276</c:v>
                </c:pt>
                <c:pt idx="12">
                  <c:v>4417.0833333333276</c:v>
                </c:pt>
                <c:pt idx="13">
                  <c:v>4052.0833333333508</c:v>
                </c:pt>
                <c:pt idx="15">
                  <c:v>117.75</c:v>
                </c:pt>
                <c:pt idx="16">
                  <c:v>27.692307692307686</c:v>
                </c:pt>
                <c:pt idx="17">
                  <c:v>55.84615384615406</c:v>
                </c:pt>
                <c:pt idx="18">
                  <c:v>174.23076923076843</c:v>
                </c:pt>
              </c:numCache>
            </c:numRef>
          </c:yVal>
        </c:ser>
        <c:ser>
          <c:idx val="8"/>
          <c:order val="8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cytokine!$C$1:$U$1</c:f>
              <c:strCache>
                <c:ptCount val="19"/>
                <c:pt idx="0">
                  <c:v>Basal-IFNg</c:v>
                </c:pt>
                <c:pt idx="1">
                  <c:v>Fn-IFNg</c:v>
                </c:pt>
                <c:pt idx="2">
                  <c:v>Td-IFNg</c:v>
                </c:pt>
                <c:pt idx="3">
                  <c:v>TT-IFNg</c:v>
                </c:pt>
                <c:pt idx="5">
                  <c:v>Basal-IL4</c:v>
                </c:pt>
                <c:pt idx="6">
                  <c:v>Fn-IL4</c:v>
                </c:pt>
                <c:pt idx="7">
                  <c:v>Td-IL4</c:v>
                </c:pt>
                <c:pt idx="8">
                  <c:v>TT-IL4</c:v>
                </c:pt>
                <c:pt idx="10">
                  <c:v>Basal-IL10</c:v>
                </c:pt>
                <c:pt idx="11">
                  <c:v>Fn-IL10</c:v>
                </c:pt>
                <c:pt idx="12">
                  <c:v>Td-IL10</c:v>
                </c:pt>
                <c:pt idx="13">
                  <c:v>TT-IL10</c:v>
                </c:pt>
                <c:pt idx="15">
                  <c:v>Basal-IL17</c:v>
                </c:pt>
                <c:pt idx="16">
                  <c:v>Fn-IL17</c:v>
                </c:pt>
                <c:pt idx="17">
                  <c:v>Td-IL17</c:v>
                </c:pt>
                <c:pt idx="18">
                  <c:v>TT-IL17</c:v>
                </c:pt>
              </c:strCache>
            </c:strRef>
          </c:xVal>
          <c:yVal>
            <c:numRef>
              <c:f>cytokine!$C$10:$U$10</c:f>
              <c:numCache>
                <c:formatCode>0.0_ </c:formatCode>
                <c:ptCount val="19"/>
                <c:pt idx="0">
                  <c:v>78.599999999999994</c:v>
                </c:pt>
                <c:pt idx="1">
                  <c:v>775.60000000000014</c:v>
                </c:pt>
                <c:pt idx="2">
                  <c:v>1994</c:v>
                </c:pt>
                <c:pt idx="3">
                  <c:v>6584</c:v>
                </c:pt>
                <c:pt idx="5">
                  <c:v>1.2857142857142778</c:v>
                </c:pt>
                <c:pt idx="6">
                  <c:v>0.46428571428571302</c:v>
                </c:pt>
                <c:pt idx="7">
                  <c:v>0.92857142857142805</c:v>
                </c:pt>
                <c:pt idx="8">
                  <c:v>1.9285714285714313</c:v>
                </c:pt>
                <c:pt idx="10">
                  <c:v>28.750000000000071</c:v>
                </c:pt>
                <c:pt idx="11">
                  <c:v>2210</c:v>
                </c:pt>
                <c:pt idx="12">
                  <c:v>3409.1666666666461</c:v>
                </c:pt>
                <c:pt idx="13">
                  <c:v>2985.4166666666647</c:v>
                </c:pt>
                <c:pt idx="15">
                  <c:v>83.235294117647072</c:v>
                </c:pt>
                <c:pt idx="16">
                  <c:v>101.235294117647</c:v>
                </c:pt>
                <c:pt idx="17">
                  <c:v>132.29411764705878</c:v>
                </c:pt>
                <c:pt idx="18">
                  <c:v>151.23529411764699</c:v>
                </c:pt>
              </c:numCache>
            </c:numRef>
          </c:yVal>
        </c:ser>
        <c:ser>
          <c:idx val="9"/>
          <c:order val="9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cytokine!$C$1:$U$1</c:f>
              <c:strCache>
                <c:ptCount val="19"/>
                <c:pt idx="0">
                  <c:v>Basal-IFNg</c:v>
                </c:pt>
                <c:pt idx="1">
                  <c:v>Fn-IFNg</c:v>
                </c:pt>
                <c:pt idx="2">
                  <c:v>Td-IFNg</c:v>
                </c:pt>
                <c:pt idx="3">
                  <c:v>TT-IFNg</c:v>
                </c:pt>
                <c:pt idx="5">
                  <c:v>Basal-IL4</c:v>
                </c:pt>
                <c:pt idx="6">
                  <c:v>Fn-IL4</c:v>
                </c:pt>
                <c:pt idx="7">
                  <c:v>Td-IL4</c:v>
                </c:pt>
                <c:pt idx="8">
                  <c:v>TT-IL4</c:v>
                </c:pt>
                <c:pt idx="10">
                  <c:v>Basal-IL10</c:v>
                </c:pt>
                <c:pt idx="11">
                  <c:v>Fn-IL10</c:v>
                </c:pt>
                <c:pt idx="12">
                  <c:v>Td-IL10</c:v>
                </c:pt>
                <c:pt idx="13">
                  <c:v>TT-IL10</c:v>
                </c:pt>
                <c:pt idx="15">
                  <c:v>Basal-IL17</c:v>
                </c:pt>
                <c:pt idx="16">
                  <c:v>Fn-IL17</c:v>
                </c:pt>
                <c:pt idx="17">
                  <c:v>Td-IL17</c:v>
                </c:pt>
                <c:pt idx="18">
                  <c:v>TT-IL17</c:v>
                </c:pt>
              </c:strCache>
            </c:strRef>
          </c:xVal>
          <c:yVal>
            <c:numRef>
              <c:f>cytokine!$C$11:$U$11</c:f>
              <c:numCache>
                <c:formatCode>0.0_ </c:formatCode>
                <c:ptCount val="19"/>
                <c:pt idx="0">
                  <c:v>61.20000000000001</c:v>
                </c:pt>
                <c:pt idx="1">
                  <c:v>348.4</c:v>
                </c:pt>
                <c:pt idx="2">
                  <c:v>611.00000000000011</c:v>
                </c:pt>
                <c:pt idx="3">
                  <c:v>4293.6000000000004</c:v>
                </c:pt>
                <c:pt idx="5">
                  <c:v>0.28571428571428525</c:v>
                </c:pt>
                <c:pt idx="6">
                  <c:v>1.0000000000000005E-2</c:v>
                </c:pt>
                <c:pt idx="7">
                  <c:v>0.14285714285714268</c:v>
                </c:pt>
                <c:pt idx="8">
                  <c:v>1.0000000000000005E-2</c:v>
                </c:pt>
                <c:pt idx="10">
                  <c:v>4.5833333333334103</c:v>
                </c:pt>
                <c:pt idx="11">
                  <c:v>2884.5833333333508</c:v>
                </c:pt>
                <c:pt idx="12">
                  <c:v>3439.1666666666461</c:v>
                </c:pt>
                <c:pt idx="13">
                  <c:v>3295.8333333333644</c:v>
                </c:pt>
                <c:pt idx="15">
                  <c:v>176.35294117647138</c:v>
                </c:pt>
                <c:pt idx="16">
                  <c:v>131.4117647058815</c:v>
                </c:pt>
                <c:pt idx="17">
                  <c:v>158.4117647058815</c:v>
                </c:pt>
                <c:pt idx="18">
                  <c:v>200.76470588235219</c:v>
                </c:pt>
              </c:numCache>
            </c:numRef>
          </c:yVal>
        </c:ser>
        <c:ser>
          <c:idx val="10"/>
          <c:order val="10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cytokine!$C$1:$U$1</c:f>
              <c:strCache>
                <c:ptCount val="19"/>
                <c:pt idx="0">
                  <c:v>Basal-IFNg</c:v>
                </c:pt>
                <c:pt idx="1">
                  <c:v>Fn-IFNg</c:v>
                </c:pt>
                <c:pt idx="2">
                  <c:v>Td-IFNg</c:v>
                </c:pt>
                <c:pt idx="3">
                  <c:v>TT-IFNg</c:v>
                </c:pt>
                <c:pt idx="5">
                  <c:v>Basal-IL4</c:v>
                </c:pt>
                <c:pt idx="6">
                  <c:v>Fn-IL4</c:v>
                </c:pt>
                <c:pt idx="7">
                  <c:v>Td-IL4</c:v>
                </c:pt>
                <c:pt idx="8">
                  <c:v>TT-IL4</c:v>
                </c:pt>
                <c:pt idx="10">
                  <c:v>Basal-IL10</c:v>
                </c:pt>
                <c:pt idx="11">
                  <c:v>Fn-IL10</c:v>
                </c:pt>
                <c:pt idx="12">
                  <c:v>Td-IL10</c:v>
                </c:pt>
                <c:pt idx="13">
                  <c:v>TT-IL10</c:v>
                </c:pt>
                <c:pt idx="15">
                  <c:v>Basal-IL17</c:v>
                </c:pt>
                <c:pt idx="16">
                  <c:v>Fn-IL17</c:v>
                </c:pt>
                <c:pt idx="17">
                  <c:v>Td-IL17</c:v>
                </c:pt>
                <c:pt idx="18">
                  <c:v>TT-IL17</c:v>
                </c:pt>
              </c:strCache>
            </c:strRef>
          </c:xVal>
          <c:yVal>
            <c:numRef>
              <c:f>cytokine!$C$12:$U$12</c:f>
              <c:numCache>
                <c:formatCode>0.0_ </c:formatCode>
                <c:ptCount val="19"/>
                <c:pt idx="0">
                  <c:v>87.399999999999977</c:v>
                </c:pt>
                <c:pt idx="1">
                  <c:v>805.4</c:v>
                </c:pt>
                <c:pt idx="2">
                  <c:v>2864.4</c:v>
                </c:pt>
                <c:pt idx="3">
                  <c:v>7103</c:v>
                </c:pt>
                <c:pt idx="5">
                  <c:v>2.5357142857142838</c:v>
                </c:pt>
                <c:pt idx="6">
                  <c:v>1.9999999999999978</c:v>
                </c:pt>
                <c:pt idx="7">
                  <c:v>1.4642857142857184</c:v>
                </c:pt>
                <c:pt idx="8">
                  <c:v>1.0714285714285701</c:v>
                </c:pt>
                <c:pt idx="10">
                  <c:v>25.000000000000021</c:v>
                </c:pt>
                <c:pt idx="11">
                  <c:v>5196.2500000000009</c:v>
                </c:pt>
                <c:pt idx="12">
                  <c:v>7264.1666666667161</c:v>
                </c:pt>
                <c:pt idx="13">
                  <c:v>5127.9166666667015</c:v>
                </c:pt>
                <c:pt idx="15">
                  <c:v>257.76470588235338</c:v>
                </c:pt>
                <c:pt idx="16">
                  <c:v>156.47058823529414</c:v>
                </c:pt>
                <c:pt idx="17">
                  <c:v>176.76470588235219</c:v>
                </c:pt>
                <c:pt idx="18">
                  <c:v>349.29411764705713</c:v>
                </c:pt>
              </c:numCache>
            </c:numRef>
          </c:yVal>
        </c:ser>
        <c:ser>
          <c:idx val="11"/>
          <c:order val="11"/>
          <c:spPr>
            <a:ln w="28575">
              <a:noFill/>
            </a:ln>
          </c:spPr>
          <c:marker>
            <c:symbol val="dash"/>
            <c:size val="1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cytokine!$C$1:$U$1</c:f>
              <c:strCache>
                <c:ptCount val="19"/>
                <c:pt idx="0">
                  <c:v>Basal-IFNg</c:v>
                </c:pt>
                <c:pt idx="1">
                  <c:v>Fn-IFNg</c:v>
                </c:pt>
                <c:pt idx="2">
                  <c:v>Td-IFNg</c:v>
                </c:pt>
                <c:pt idx="3">
                  <c:v>TT-IFNg</c:v>
                </c:pt>
                <c:pt idx="5">
                  <c:v>Basal-IL4</c:v>
                </c:pt>
                <c:pt idx="6">
                  <c:v>Fn-IL4</c:v>
                </c:pt>
                <c:pt idx="7">
                  <c:v>Td-IL4</c:v>
                </c:pt>
                <c:pt idx="8">
                  <c:v>TT-IL4</c:v>
                </c:pt>
                <c:pt idx="10">
                  <c:v>Basal-IL10</c:v>
                </c:pt>
                <c:pt idx="11">
                  <c:v>Fn-IL10</c:v>
                </c:pt>
                <c:pt idx="12">
                  <c:v>Td-IL10</c:v>
                </c:pt>
                <c:pt idx="13">
                  <c:v>TT-IL10</c:v>
                </c:pt>
                <c:pt idx="15">
                  <c:v>Basal-IL17</c:v>
                </c:pt>
                <c:pt idx="16">
                  <c:v>Fn-IL17</c:v>
                </c:pt>
                <c:pt idx="17">
                  <c:v>Td-IL17</c:v>
                </c:pt>
                <c:pt idx="18">
                  <c:v>TT-IL17</c:v>
                </c:pt>
              </c:strCache>
            </c:strRef>
          </c:xVal>
          <c:yVal>
            <c:numRef>
              <c:f>cytokine!$C$13:$U$13</c:f>
              <c:numCache>
                <c:formatCode>0.0_ </c:formatCode>
                <c:ptCount val="19"/>
                <c:pt idx="0">
                  <c:v>78.599999999999994</c:v>
                </c:pt>
                <c:pt idx="1">
                  <c:v>348.4</c:v>
                </c:pt>
                <c:pt idx="2">
                  <c:v>670.2</c:v>
                </c:pt>
                <c:pt idx="3">
                  <c:v>3357.8</c:v>
                </c:pt>
                <c:pt idx="5">
                  <c:v>0.69642857142857351</c:v>
                </c:pt>
                <c:pt idx="6">
                  <c:v>0.17857142857142869</c:v>
                </c:pt>
                <c:pt idx="7">
                  <c:v>0.124999999999999</c:v>
                </c:pt>
                <c:pt idx="8">
                  <c:v>0.14785714285714277</c:v>
                </c:pt>
                <c:pt idx="10">
                  <c:v>28.750000000000071</c:v>
                </c:pt>
                <c:pt idx="11">
                  <c:v>4571.6666666667161</c:v>
                </c:pt>
                <c:pt idx="12">
                  <c:v>4417.0833333333276</c:v>
                </c:pt>
                <c:pt idx="13">
                  <c:v>4052.0833333333508</c:v>
                </c:pt>
                <c:pt idx="15">
                  <c:v>117.75</c:v>
                </c:pt>
                <c:pt idx="16">
                  <c:v>108.3461538461539</c:v>
                </c:pt>
                <c:pt idx="17">
                  <c:v>158.4117647058815</c:v>
                </c:pt>
                <c:pt idx="18">
                  <c:v>229.96153846153851</c:v>
                </c:pt>
              </c:numCache>
            </c:numRef>
          </c:yVal>
        </c:ser>
        <c:axId val="107714432"/>
        <c:axId val="107722624"/>
      </c:scatterChart>
      <c:valAx>
        <c:axId val="107714432"/>
        <c:scaling>
          <c:orientation val="minMax"/>
        </c:scaling>
        <c:axPos val="b"/>
        <c:tickLblPos val="none"/>
        <c:spPr>
          <a:ln w="15875">
            <a:solidFill>
              <a:sysClr val="windowText" lastClr="000000"/>
            </a:solidFill>
          </a:ln>
        </c:spPr>
        <c:crossAx val="107722624"/>
        <c:crossesAt val="1.0000000000000005E-2"/>
        <c:crossBetween val="midCat"/>
      </c:valAx>
      <c:valAx>
        <c:axId val="107722624"/>
        <c:scaling>
          <c:logBase val="10"/>
          <c:orientation val="minMax"/>
          <c:min val="1.0000000000000005E-2"/>
        </c:scaling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Calibri" pitchFamily="34" charset="0"/>
                    <a:cs typeface="Calibri" pitchFamily="34" charset="0"/>
                  </a:defRPr>
                </a:pPr>
                <a:r>
                  <a:rPr lang="en-US" altLang="en-US" sz="1200" dirty="0">
                    <a:latin typeface="Calibri" pitchFamily="34" charset="0"/>
                    <a:cs typeface="Calibri" pitchFamily="34" charset="0"/>
                  </a:rPr>
                  <a:t>Cytokines (pg/ml)</a:t>
                </a:r>
              </a:p>
            </c:rich>
          </c:tx>
          <c:layout/>
        </c:title>
        <c:numFmt formatCode="General" sourceLinked="0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Calibri" pitchFamily="34" charset="0"/>
                <a:cs typeface="Calibri" pitchFamily="34" charset="0"/>
              </a:defRPr>
            </a:pPr>
            <a:endParaRPr lang="ko-KR"/>
          </a:p>
        </c:txPr>
        <c:crossAx val="107714432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</c:chart>
  <c:spPr>
    <a:ln>
      <a:noFill/>
    </a:ln>
  </c:sp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7B8FC-EDF8-490B-84A5-B826137B3388}" type="datetimeFigureOut">
              <a:rPr lang="ko-KR" altLang="en-US" smtClean="0"/>
              <a:t>2012-12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20C437-F216-44D7-96B4-F4EFB46B4BE7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7B8FC-EDF8-490B-84A5-B826137B3388}" type="datetimeFigureOut">
              <a:rPr lang="ko-KR" altLang="en-US" smtClean="0"/>
              <a:t>2012-12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20C437-F216-44D7-96B4-F4EFB46B4BE7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7B8FC-EDF8-490B-84A5-B826137B3388}" type="datetimeFigureOut">
              <a:rPr lang="ko-KR" altLang="en-US" smtClean="0"/>
              <a:t>2012-12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20C437-F216-44D7-96B4-F4EFB46B4BE7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7B8FC-EDF8-490B-84A5-B826137B3388}" type="datetimeFigureOut">
              <a:rPr lang="ko-KR" altLang="en-US" smtClean="0"/>
              <a:t>2012-12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20C437-F216-44D7-96B4-F4EFB46B4BE7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7B8FC-EDF8-490B-84A5-B826137B3388}" type="datetimeFigureOut">
              <a:rPr lang="ko-KR" altLang="en-US" smtClean="0"/>
              <a:t>2012-12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20C437-F216-44D7-96B4-F4EFB46B4BE7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7B8FC-EDF8-490B-84A5-B826137B3388}" type="datetimeFigureOut">
              <a:rPr lang="ko-KR" altLang="en-US" smtClean="0"/>
              <a:t>2012-12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20C437-F216-44D7-96B4-F4EFB46B4BE7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7B8FC-EDF8-490B-84A5-B826137B3388}" type="datetimeFigureOut">
              <a:rPr lang="ko-KR" altLang="en-US" smtClean="0"/>
              <a:t>2012-12-1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20C437-F216-44D7-96B4-F4EFB46B4BE7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7B8FC-EDF8-490B-84A5-B826137B3388}" type="datetimeFigureOut">
              <a:rPr lang="ko-KR" altLang="en-US" smtClean="0"/>
              <a:t>2012-12-1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20C437-F216-44D7-96B4-F4EFB46B4BE7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7B8FC-EDF8-490B-84A5-B826137B3388}" type="datetimeFigureOut">
              <a:rPr lang="ko-KR" altLang="en-US" smtClean="0"/>
              <a:t>2012-12-1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20C437-F216-44D7-96B4-F4EFB46B4BE7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7B8FC-EDF8-490B-84A5-B826137B3388}" type="datetimeFigureOut">
              <a:rPr lang="ko-KR" altLang="en-US" smtClean="0"/>
              <a:t>2012-12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20C437-F216-44D7-96B4-F4EFB46B4BE7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7B8FC-EDF8-490B-84A5-B826137B3388}" type="datetimeFigureOut">
              <a:rPr lang="ko-KR" altLang="en-US" smtClean="0"/>
              <a:t>2012-12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20C437-F216-44D7-96B4-F4EFB46B4BE7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57B8FC-EDF8-490B-84A5-B826137B3388}" type="datetimeFigureOut">
              <a:rPr lang="ko-KR" altLang="en-US" smtClean="0"/>
              <a:t>2012-12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20C437-F216-44D7-96B4-F4EFB46B4BE7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80"/>
          <p:cNvGrpSpPr/>
          <p:nvPr/>
        </p:nvGrpSpPr>
        <p:grpSpPr>
          <a:xfrm>
            <a:off x="1276087" y="3613733"/>
            <a:ext cx="4360462" cy="826594"/>
            <a:chOff x="1282424" y="3613733"/>
            <a:chExt cx="4404207" cy="826594"/>
          </a:xfrm>
        </p:grpSpPr>
        <p:sp>
          <p:nvSpPr>
            <p:cNvPr id="62468" name="TextBox 55"/>
            <p:cNvSpPr txBox="1">
              <a:spLocks noChangeArrowheads="1"/>
            </p:cNvSpPr>
            <p:nvPr/>
          </p:nvSpPr>
          <p:spPr bwMode="auto">
            <a:xfrm rot="16200000">
              <a:off x="1044207" y="3854375"/>
              <a:ext cx="725126" cy="248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000" dirty="0" smtClean="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No Ag</a:t>
              </a:r>
              <a:endParaRPr kumimoji="0" lang="ko-KR" altLang="en-US" sz="1000" dirty="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sp>
          <p:nvSpPr>
            <p:cNvPr id="62469" name="TextBox 2"/>
            <p:cNvSpPr txBox="1">
              <a:spLocks noChangeArrowheads="1"/>
            </p:cNvSpPr>
            <p:nvPr/>
          </p:nvSpPr>
          <p:spPr bwMode="auto">
            <a:xfrm rot="16200000">
              <a:off x="1860465" y="3746549"/>
              <a:ext cx="503964" cy="248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00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TT</a:t>
              </a:r>
              <a:endParaRPr kumimoji="0" lang="ko-KR" altLang="en-US" sz="100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cxnSp>
          <p:nvCxnSpPr>
            <p:cNvPr id="18" name="직선 연결선 17"/>
            <p:cNvCxnSpPr/>
            <p:nvPr/>
          </p:nvCxnSpPr>
          <p:spPr bwMode="auto">
            <a:xfrm>
              <a:off x="1375660" y="4156165"/>
              <a:ext cx="77647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471" name="TextBox 11"/>
            <p:cNvSpPr txBox="1">
              <a:spLocks noChangeArrowheads="1"/>
            </p:cNvSpPr>
            <p:nvPr/>
          </p:nvSpPr>
          <p:spPr bwMode="auto">
            <a:xfrm>
              <a:off x="1377513" y="4163378"/>
              <a:ext cx="776298" cy="2769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kumimoji="0" lang="en-US" altLang="ko-KR" sz="1200" b="1" dirty="0" err="1" smtClean="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IFN</a:t>
              </a:r>
              <a:r>
                <a:rPr kumimoji="0" lang="en-US" altLang="ko-KR" sz="1200" b="1" dirty="0" err="1" smtClean="0">
                  <a:latin typeface="Symbol" pitchFamily="18" charset="2"/>
                  <a:ea typeface="휴먼매직체" pitchFamily="18" charset="-127"/>
                  <a:cs typeface="Calibri" pitchFamily="34" charset="0"/>
                </a:rPr>
                <a:t>g</a:t>
              </a:r>
              <a:endParaRPr kumimoji="0" lang="ko-KR" altLang="en-US" sz="1200" b="1" dirty="0">
                <a:latin typeface="Symbol" pitchFamily="18" charset="2"/>
                <a:ea typeface="맑은 고딕" pitchFamily="50" charset="-127"/>
                <a:cs typeface="Calibri" pitchFamily="34" charset="0"/>
              </a:endParaRPr>
            </a:p>
          </p:txBody>
        </p:sp>
        <p:sp>
          <p:nvSpPr>
            <p:cNvPr id="62473" name="TextBox 55"/>
            <p:cNvSpPr txBox="1">
              <a:spLocks noChangeArrowheads="1"/>
            </p:cNvSpPr>
            <p:nvPr/>
          </p:nvSpPr>
          <p:spPr bwMode="auto">
            <a:xfrm rot="16200000">
              <a:off x="1295226" y="3851951"/>
              <a:ext cx="725126" cy="248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000" dirty="0" err="1" smtClean="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FadA</a:t>
              </a:r>
              <a:endParaRPr kumimoji="0" lang="ko-KR" altLang="en-US" sz="1000" dirty="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sp>
          <p:nvSpPr>
            <p:cNvPr id="62474" name="TextBox 55"/>
            <p:cNvSpPr txBox="1">
              <a:spLocks noChangeArrowheads="1"/>
            </p:cNvSpPr>
            <p:nvPr/>
          </p:nvSpPr>
          <p:spPr bwMode="auto">
            <a:xfrm rot="16200000">
              <a:off x="1517355" y="3851951"/>
              <a:ext cx="725126" cy="248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000" dirty="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Td92</a:t>
              </a:r>
              <a:endParaRPr kumimoji="0" lang="ko-KR" altLang="en-US" sz="1000" dirty="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sp>
          <p:nvSpPr>
            <p:cNvPr id="62475" name="TextBox 55"/>
            <p:cNvSpPr txBox="1">
              <a:spLocks noChangeArrowheads="1"/>
            </p:cNvSpPr>
            <p:nvPr/>
          </p:nvSpPr>
          <p:spPr bwMode="auto">
            <a:xfrm rot="16200000">
              <a:off x="2217377" y="3854373"/>
              <a:ext cx="725126" cy="248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000" dirty="0" smtClean="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No Ag</a:t>
              </a:r>
              <a:endParaRPr kumimoji="0" lang="ko-KR" altLang="en-US" sz="1000" dirty="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sp>
          <p:nvSpPr>
            <p:cNvPr id="62476" name="TextBox 2"/>
            <p:cNvSpPr txBox="1">
              <a:spLocks noChangeArrowheads="1"/>
            </p:cNvSpPr>
            <p:nvPr/>
          </p:nvSpPr>
          <p:spPr bwMode="auto">
            <a:xfrm rot="16200000">
              <a:off x="2991943" y="3746547"/>
              <a:ext cx="503964" cy="248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00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TT</a:t>
              </a:r>
              <a:endParaRPr kumimoji="0" lang="ko-KR" altLang="en-US" sz="100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cxnSp>
          <p:nvCxnSpPr>
            <p:cNvPr id="35" name="직선 연결선 34"/>
            <p:cNvCxnSpPr/>
            <p:nvPr/>
          </p:nvCxnSpPr>
          <p:spPr bwMode="auto">
            <a:xfrm>
              <a:off x="2527151" y="4154577"/>
              <a:ext cx="77647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478" name="TextBox 11"/>
            <p:cNvSpPr txBox="1">
              <a:spLocks noChangeArrowheads="1"/>
            </p:cNvSpPr>
            <p:nvPr/>
          </p:nvSpPr>
          <p:spPr bwMode="auto">
            <a:xfrm>
              <a:off x="2529839" y="4163378"/>
              <a:ext cx="776298" cy="2769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kumimoji="0" lang="en-US" altLang="ko-KR" sz="1200" b="1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IL-4</a:t>
              </a:r>
              <a:endParaRPr kumimoji="0" lang="ko-KR" altLang="en-US" sz="1200" b="1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sp>
          <p:nvSpPr>
            <p:cNvPr id="62479" name="TextBox 55"/>
            <p:cNvSpPr txBox="1">
              <a:spLocks noChangeArrowheads="1"/>
            </p:cNvSpPr>
            <p:nvPr/>
          </p:nvSpPr>
          <p:spPr bwMode="auto">
            <a:xfrm rot="16200000">
              <a:off x="2437125" y="3851950"/>
              <a:ext cx="725126" cy="248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000" dirty="0" err="1" smtClean="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FadA</a:t>
              </a:r>
              <a:endParaRPr kumimoji="0" lang="ko-KR" altLang="en-US" sz="1000" dirty="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sp>
          <p:nvSpPr>
            <p:cNvPr id="62480" name="TextBox 55"/>
            <p:cNvSpPr txBox="1">
              <a:spLocks noChangeArrowheads="1"/>
            </p:cNvSpPr>
            <p:nvPr/>
          </p:nvSpPr>
          <p:spPr bwMode="auto">
            <a:xfrm rot="16200000">
              <a:off x="2648831" y="3851950"/>
              <a:ext cx="725126" cy="248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00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Td92</a:t>
              </a:r>
              <a:endParaRPr kumimoji="0" lang="ko-KR" altLang="en-US" sz="100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sp>
          <p:nvSpPr>
            <p:cNvPr id="62481" name="TextBox 55"/>
            <p:cNvSpPr txBox="1">
              <a:spLocks noChangeArrowheads="1"/>
            </p:cNvSpPr>
            <p:nvPr/>
          </p:nvSpPr>
          <p:spPr bwMode="auto">
            <a:xfrm rot="16200000">
              <a:off x="3354526" y="3854375"/>
              <a:ext cx="725126" cy="248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000" dirty="0" smtClean="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No Ag</a:t>
              </a:r>
              <a:endParaRPr kumimoji="0" lang="ko-KR" altLang="en-US" sz="1000" dirty="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sp>
          <p:nvSpPr>
            <p:cNvPr id="62482" name="TextBox 2"/>
            <p:cNvSpPr txBox="1">
              <a:spLocks noChangeArrowheads="1"/>
            </p:cNvSpPr>
            <p:nvPr/>
          </p:nvSpPr>
          <p:spPr bwMode="auto">
            <a:xfrm rot="16200000">
              <a:off x="4160361" y="3746549"/>
              <a:ext cx="503964" cy="248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00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TT</a:t>
              </a:r>
              <a:endParaRPr kumimoji="0" lang="ko-KR" altLang="en-US" sz="100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cxnSp>
          <p:nvCxnSpPr>
            <p:cNvPr id="41" name="직선 연결선 40"/>
            <p:cNvCxnSpPr/>
            <p:nvPr/>
          </p:nvCxnSpPr>
          <p:spPr bwMode="auto">
            <a:xfrm>
              <a:off x="3689535" y="4152990"/>
              <a:ext cx="77647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484" name="TextBox 11"/>
            <p:cNvSpPr txBox="1">
              <a:spLocks noChangeArrowheads="1"/>
            </p:cNvSpPr>
            <p:nvPr/>
          </p:nvSpPr>
          <p:spPr bwMode="auto">
            <a:xfrm>
              <a:off x="3666990" y="4163378"/>
              <a:ext cx="776298" cy="2769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kumimoji="0" lang="en-US" altLang="ko-KR" sz="1200" b="1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IL-10</a:t>
              </a:r>
              <a:endParaRPr kumimoji="0" lang="ko-KR" altLang="en-US" sz="1200" b="1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sp>
          <p:nvSpPr>
            <p:cNvPr id="62485" name="TextBox 55"/>
            <p:cNvSpPr txBox="1">
              <a:spLocks noChangeArrowheads="1"/>
            </p:cNvSpPr>
            <p:nvPr/>
          </p:nvSpPr>
          <p:spPr bwMode="auto">
            <a:xfrm rot="16200000">
              <a:off x="3584697" y="3851952"/>
              <a:ext cx="725126" cy="248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000" dirty="0" err="1" smtClean="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FadA</a:t>
              </a:r>
              <a:endParaRPr kumimoji="0" lang="ko-KR" altLang="en-US" sz="1000" dirty="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sp>
          <p:nvSpPr>
            <p:cNvPr id="62486" name="TextBox 55"/>
            <p:cNvSpPr txBox="1">
              <a:spLocks noChangeArrowheads="1"/>
            </p:cNvSpPr>
            <p:nvPr/>
          </p:nvSpPr>
          <p:spPr bwMode="auto">
            <a:xfrm rot="16200000">
              <a:off x="3817249" y="3851952"/>
              <a:ext cx="725126" cy="248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000" dirty="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Td92</a:t>
              </a:r>
              <a:endParaRPr kumimoji="0" lang="ko-KR" altLang="en-US" sz="1000" dirty="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sp>
          <p:nvSpPr>
            <p:cNvPr id="62487" name="TextBox 55"/>
            <p:cNvSpPr txBox="1">
              <a:spLocks noChangeArrowheads="1"/>
            </p:cNvSpPr>
            <p:nvPr/>
          </p:nvSpPr>
          <p:spPr bwMode="auto">
            <a:xfrm rot="16200000">
              <a:off x="4494045" y="3854375"/>
              <a:ext cx="725126" cy="248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000" dirty="0" smtClean="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No Ag</a:t>
              </a:r>
              <a:endParaRPr kumimoji="0" lang="ko-KR" altLang="en-US" sz="1000" dirty="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sp>
          <p:nvSpPr>
            <p:cNvPr id="62488" name="TextBox 2"/>
            <p:cNvSpPr txBox="1">
              <a:spLocks noChangeArrowheads="1"/>
            </p:cNvSpPr>
            <p:nvPr/>
          </p:nvSpPr>
          <p:spPr bwMode="auto">
            <a:xfrm rot="16200000">
              <a:off x="5310304" y="3746549"/>
              <a:ext cx="503964" cy="248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00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TT</a:t>
              </a:r>
              <a:endParaRPr kumimoji="0" lang="ko-KR" altLang="en-US" sz="100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cxnSp>
          <p:nvCxnSpPr>
            <p:cNvPr id="47" name="직선 연결선 46"/>
            <p:cNvCxnSpPr/>
            <p:nvPr/>
          </p:nvCxnSpPr>
          <p:spPr bwMode="auto">
            <a:xfrm>
              <a:off x="4825465" y="4154577"/>
              <a:ext cx="77647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490" name="TextBox 11"/>
            <p:cNvSpPr txBox="1">
              <a:spLocks noChangeArrowheads="1"/>
            </p:cNvSpPr>
            <p:nvPr/>
          </p:nvSpPr>
          <p:spPr bwMode="auto">
            <a:xfrm>
              <a:off x="4806511" y="4163378"/>
              <a:ext cx="776298" cy="2769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kumimoji="0" lang="en-US" altLang="ko-KR" sz="1200" b="1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IL-17</a:t>
              </a:r>
              <a:endParaRPr kumimoji="0" lang="ko-KR" altLang="en-US" sz="1200" b="1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sp>
          <p:nvSpPr>
            <p:cNvPr id="62491" name="TextBox 55"/>
            <p:cNvSpPr txBox="1">
              <a:spLocks noChangeArrowheads="1"/>
            </p:cNvSpPr>
            <p:nvPr/>
          </p:nvSpPr>
          <p:spPr bwMode="auto">
            <a:xfrm rot="16200000">
              <a:off x="4724217" y="3851952"/>
              <a:ext cx="725126" cy="248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000" dirty="0" err="1" smtClean="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FadA</a:t>
              </a:r>
              <a:endParaRPr kumimoji="0" lang="ko-KR" altLang="en-US" sz="1000" dirty="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sp>
          <p:nvSpPr>
            <p:cNvPr id="62492" name="TextBox 55"/>
            <p:cNvSpPr txBox="1">
              <a:spLocks noChangeArrowheads="1"/>
            </p:cNvSpPr>
            <p:nvPr/>
          </p:nvSpPr>
          <p:spPr bwMode="auto">
            <a:xfrm rot="16200000">
              <a:off x="4967192" y="3851952"/>
              <a:ext cx="725126" cy="248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00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Td92</a:t>
              </a:r>
              <a:endParaRPr kumimoji="0" lang="ko-KR" altLang="en-US" sz="100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</p:grpSp>
      <p:graphicFrame>
        <p:nvGraphicFramePr>
          <p:cNvPr id="74" name="차트 73"/>
          <p:cNvGraphicFramePr>
            <a:graphicFrameLocks/>
          </p:cNvGraphicFramePr>
          <p:nvPr/>
        </p:nvGraphicFramePr>
        <p:xfrm>
          <a:off x="545561" y="956454"/>
          <a:ext cx="5124450" cy="285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5" name="직사각형 104"/>
          <p:cNvSpPr/>
          <p:nvPr/>
        </p:nvSpPr>
        <p:spPr>
          <a:xfrm>
            <a:off x="778654" y="3571336"/>
            <a:ext cx="345056" cy="18115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933929" y="3510951"/>
            <a:ext cx="1984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Calibri" pitchFamily="34" charset="0"/>
                <a:cs typeface="Calibri" pitchFamily="34" charset="0"/>
              </a:rPr>
              <a:t>0</a:t>
            </a:r>
            <a:endParaRPr lang="ko-KR" altLang="en-US" sz="1000" dirty="0">
              <a:latin typeface="Calibri" pitchFamily="34" charset="0"/>
              <a:cs typeface="Calibri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0" y="0"/>
            <a:ext cx="11640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ure S3</a:t>
            </a:r>
            <a:endParaRPr lang="ko-KR" altLang="en-US" dirty="0"/>
          </a:p>
        </p:txBody>
      </p:sp>
      <p:grpSp>
        <p:nvGrpSpPr>
          <p:cNvPr id="3" name="그룹 68"/>
          <p:cNvGrpSpPr/>
          <p:nvPr/>
        </p:nvGrpSpPr>
        <p:grpSpPr>
          <a:xfrm>
            <a:off x="4862422" y="942784"/>
            <a:ext cx="543111" cy="342401"/>
            <a:chOff x="4862422" y="782458"/>
            <a:chExt cx="543111" cy="342401"/>
          </a:xfrm>
        </p:grpSpPr>
        <p:sp>
          <p:nvSpPr>
            <p:cNvPr id="114" name="TextBox 214"/>
            <p:cNvSpPr txBox="1">
              <a:spLocks noChangeArrowheads="1"/>
            </p:cNvSpPr>
            <p:nvPr/>
          </p:nvSpPr>
          <p:spPr bwMode="auto">
            <a:xfrm>
              <a:off x="5097923" y="894023"/>
              <a:ext cx="30761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ko-KR" sz="900" dirty="0" smtClean="0">
                  <a:latin typeface="Calibri" pitchFamily="34" charset="0"/>
                  <a:cs typeface="Calibri" pitchFamily="34" charset="0"/>
                </a:rPr>
                <a:t>#</a:t>
              </a:r>
              <a:endParaRPr lang="ko-KR" altLang="en-US" sz="900" dirty="0">
                <a:latin typeface="Calibri" pitchFamily="34" charset="0"/>
                <a:cs typeface="Calibri" pitchFamily="34" charset="0"/>
              </a:endParaRPr>
            </a:p>
          </p:txBody>
        </p:sp>
        <p:sp>
          <p:nvSpPr>
            <p:cNvPr id="119" name="TextBox 213"/>
            <p:cNvSpPr txBox="1">
              <a:spLocks noChangeArrowheads="1"/>
            </p:cNvSpPr>
            <p:nvPr/>
          </p:nvSpPr>
          <p:spPr bwMode="auto">
            <a:xfrm>
              <a:off x="4862422" y="894027"/>
              <a:ext cx="448663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ko-KR" sz="900" dirty="0" smtClean="0">
                  <a:latin typeface="Calibri" pitchFamily="34" charset="0"/>
                  <a:cs typeface="Calibri" pitchFamily="34" charset="0"/>
                </a:rPr>
                <a:t> ##</a:t>
              </a:r>
              <a:endParaRPr lang="ko-KR" altLang="en-US" sz="900" dirty="0">
                <a:latin typeface="Calibri" pitchFamily="34" charset="0"/>
                <a:cs typeface="Calibri" pitchFamily="34" charset="0"/>
              </a:endParaRPr>
            </a:p>
          </p:txBody>
        </p:sp>
        <p:sp>
          <p:nvSpPr>
            <p:cNvPr id="120" name="TextBox 215"/>
            <p:cNvSpPr txBox="1">
              <a:spLocks noChangeArrowheads="1"/>
            </p:cNvSpPr>
            <p:nvPr/>
          </p:nvSpPr>
          <p:spPr bwMode="auto">
            <a:xfrm>
              <a:off x="4959153" y="782458"/>
              <a:ext cx="417051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ko-KR" sz="900" dirty="0" smtClean="0">
                  <a:latin typeface="Calibri" pitchFamily="34" charset="0"/>
                  <a:cs typeface="Calibri" pitchFamily="34" charset="0"/>
                </a:rPr>
                <a:t>##</a:t>
              </a:r>
              <a:endParaRPr lang="ko-KR" altLang="en-US" sz="900" dirty="0">
                <a:latin typeface="Calibri" pitchFamily="34" charset="0"/>
                <a:cs typeface="Calibri" pitchFamily="34" charset="0"/>
              </a:endParaRPr>
            </a:p>
          </p:txBody>
        </p:sp>
        <p:sp>
          <p:nvSpPr>
            <p:cNvPr id="57" name="왼쪽 대괄호 56"/>
            <p:cNvSpPr/>
            <p:nvPr/>
          </p:nvSpPr>
          <p:spPr>
            <a:xfrm rot="5400000">
              <a:off x="5086124" y="765522"/>
              <a:ext cx="74139" cy="425496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 sz="900"/>
            </a:p>
          </p:txBody>
        </p:sp>
        <p:sp>
          <p:nvSpPr>
            <p:cNvPr id="58" name="왼쪽 대괄호 57"/>
            <p:cNvSpPr/>
            <p:nvPr/>
          </p:nvSpPr>
          <p:spPr>
            <a:xfrm rot="5400000">
              <a:off x="4982383" y="972591"/>
              <a:ext cx="63833" cy="207706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 sz="900"/>
            </a:p>
          </p:txBody>
        </p:sp>
        <p:sp>
          <p:nvSpPr>
            <p:cNvPr id="59" name="왼쪽 대괄호 58"/>
            <p:cNvSpPr/>
            <p:nvPr/>
          </p:nvSpPr>
          <p:spPr>
            <a:xfrm rot="5400000">
              <a:off x="5194160" y="972591"/>
              <a:ext cx="63833" cy="207706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 sz="900"/>
            </a:p>
          </p:txBody>
        </p:sp>
      </p:grpSp>
      <p:grpSp>
        <p:nvGrpSpPr>
          <p:cNvPr id="4" name="그룹 67"/>
          <p:cNvGrpSpPr/>
          <p:nvPr/>
        </p:nvGrpSpPr>
        <p:grpSpPr>
          <a:xfrm>
            <a:off x="1594687" y="942784"/>
            <a:ext cx="596309" cy="342401"/>
            <a:chOff x="1594687" y="774542"/>
            <a:chExt cx="596309" cy="342401"/>
          </a:xfrm>
        </p:grpSpPr>
        <p:sp>
          <p:nvSpPr>
            <p:cNvPr id="60" name="TextBox 214"/>
            <p:cNvSpPr txBox="1">
              <a:spLocks noChangeArrowheads="1"/>
            </p:cNvSpPr>
            <p:nvPr/>
          </p:nvSpPr>
          <p:spPr bwMode="auto">
            <a:xfrm>
              <a:off x="1806436" y="886107"/>
              <a:ext cx="38456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ko-KR" sz="900" dirty="0" smtClean="0">
                  <a:latin typeface="Calibri" pitchFamily="34" charset="0"/>
                  <a:cs typeface="Calibri" pitchFamily="34" charset="0"/>
                </a:rPr>
                <a:t>##</a:t>
              </a:r>
              <a:endParaRPr lang="ko-KR" altLang="en-US" sz="900" dirty="0">
                <a:latin typeface="Calibri" pitchFamily="34" charset="0"/>
                <a:cs typeface="Calibri" pitchFamily="34" charset="0"/>
              </a:endParaRPr>
            </a:p>
          </p:txBody>
        </p:sp>
        <p:sp>
          <p:nvSpPr>
            <p:cNvPr id="62" name="TextBox 213"/>
            <p:cNvSpPr txBox="1">
              <a:spLocks noChangeArrowheads="1"/>
            </p:cNvSpPr>
            <p:nvPr/>
          </p:nvSpPr>
          <p:spPr bwMode="auto">
            <a:xfrm>
              <a:off x="1594687" y="886111"/>
              <a:ext cx="448663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ko-KR" sz="900" dirty="0" smtClean="0">
                  <a:latin typeface="Calibri" pitchFamily="34" charset="0"/>
                  <a:cs typeface="Calibri" pitchFamily="34" charset="0"/>
                </a:rPr>
                <a:t> ##</a:t>
              </a:r>
              <a:endParaRPr lang="ko-KR" altLang="en-US" sz="900" dirty="0">
                <a:latin typeface="Calibri" pitchFamily="34" charset="0"/>
                <a:cs typeface="Calibri" pitchFamily="34" charset="0"/>
              </a:endParaRPr>
            </a:p>
          </p:txBody>
        </p:sp>
        <p:sp>
          <p:nvSpPr>
            <p:cNvPr id="63" name="TextBox 215"/>
            <p:cNvSpPr txBox="1">
              <a:spLocks noChangeArrowheads="1"/>
            </p:cNvSpPr>
            <p:nvPr/>
          </p:nvSpPr>
          <p:spPr bwMode="auto">
            <a:xfrm>
              <a:off x="1691418" y="774542"/>
              <a:ext cx="417051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ko-KR" sz="900" dirty="0" smtClean="0">
                  <a:latin typeface="Calibri" pitchFamily="34" charset="0"/>
                  <a:cs typeface="Calibri" pitchFamily="34" charset="0"/>
                </a:rPr>
                <a:t>##</a:t>
              </a:r>
              <a:endParaRPr lang="ko-KR" altLang="en-US" sz="900" dirty="0">
                <a:latin typeface="Calibri" pitchFamily="34" charset="0"/>
                <a:cs typeface="Calibri" pitchFamily="34" charset="0"/>
              </a:endParaRPr>
            </a:p>
          </p:txBody>
        </p:sp>
        <p:sp>
          <p:nvSpPr>
            <p:cNvPr id="64" name="왼쪽 대괄호 63"/>
            <p:cNvSpPr/>
            <p:nvPr/>
          </p:nvSpPr>
          <p:spPr>
            <a:xfrm rot="5400000">
              <a:off x="1818389" y="757606"/>
              <a:ext cx="74139" cy="425496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 sz="900"/>
            </a:p>
          </p:txBody>
        </p:sp>
        <p:sp>
          <p:nvSpPr>
            <p:cNvPr id="66" name="왼쪽 대괄호 65"/>
            <p:cNvSpPr/>
            <p:nvPr/>
          </p:nvSpPr>
          <p:spPr>
            <a:xfrm rot="5400000">
              <a:off x="1714648" y="964675"/>
              <a:ext cx="63833" cy="207706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 sz="900"/>
            </a:p>
          </p:txBody>
        </p:sp>
        <p:sp>
          <p:nvSpPr>
            <p:cNvPr id="67" name="왼쪽 대괄호 66"/>
            <p:cNvSpPr/>
            <p:nvPr/>
          </p:nvSpPr>
          <p:spPr>
            <a:xfrm rot="5400000">
              <a:off x="1926425" y="964675"/>
              <a:ext cx="63833" cy="207706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 sz="900"/>
            </a:p>
          </p:txBody>
        </p:sp>
      </p:grpSp>
      <p:sp>
        <p:nvSpPr>
          <p:cNvPr id="46" name="직사각형 45"/>
          <p:cNvSpPr/>
          <p:nvPr/>
        </p:nvSpPr>
        <p:spPr>
          <a:xfrm>
            <a:off x="1511783" y="1280362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smtClean="0">
                <a:latin typeface="Calibri" pitchFamily="34" charset="0"/>
                <a:cs typeface="Calibri" pitchFamily="34" charset="0"/>
              </a:rPr>
              <a:t>*</a:t>
            </a:r>
            <a:endParaRPr lang="ko-KR" altLang="en-US" sz="1000" dirty="0"/>
          </a:p>
        </p:txBody>
      </p:sp>
      <p:sp>
        <p:nvSpPr>
          <p:cNvPr id="48" name="직사각형 47"/>
          <p:cNvSpPr/>
          <p:nvPr/>
        </p:nvSpPr>
        <p:spPr>
          <a:xfrm>
            <a:off x="1739718" y="1280362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smtClean="0">
                <a:latin typeface="Calibri" pitchFamily="34" charset="0"/>
                <a:cs typeface="Calibri" pitchFamily="34" charset="0"/>
              </a:rPr>
              <a:t>*</a:t>
            </a:r>
            <a:endParaRPr lang="ko-KR" altLang="en-US" sz="1000" dirty="0"/>
          </a:p>
        </p:txBody>
      </p:sp>
      <p:sp>
        <p:nvSpPr>
          <p:cNvPr id="49" name="직사각형 48"/>
          <p:cNvSpPr/>
          <p:nvPr/>
        </p:nvSpPr>
        <p:spPr>
          <a:xfrm>
            <a:off x="1919946" y="1280362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smtClean="0">
                <a:latin typeface="Calibri" pitchFamily="34" charset="0"/>
                <a:cs typeface="Calibri" pitchFamily="34" charset="0"/>
              </a:rPr>
              <a:t>**</a:t>
            </a:r>
            <a:endParaRPr lang="ko-KR" altLang="en-US" sz="1000" dirty="0"/>
          </a:p>
        </p:txBody>
      </p:sp>
      <p:sp>
        <p:nvSpPr>
          <p:cNvPr id="50" name="직사각형 49"/>
          <p:cNvSpPr/>
          <p:nvPr/>
        </p:nvSpPr>
        <p:spPr>
          <a:xfrm>
            <a:off x="3699717" y="1154467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smtClean="0">
                <a:latin typeface="Calibri" pitchFamily="34" charset="0"/>
                <a:cs typeface="Calibri" pitchFamily="34" charset="0"/>
              </a:rPr>
              <a:t>*</a:t>
            </a:r>
            <a:endParaRPr lang="ko-KR" altLang="en-US" sz="1000" dirty="0"/>
          </a:p>
        </p:txBody>
      </p:sp>
      <p:sp>
        <p:nvSpPr>
          <p:cNvPr id="51" name="직사각형 50"/>
          <p:cNvSpPr/>
          <p:nvPr/>
        </p:nvSpPr>
        <p:spPr>
          <a:xfrm>
            <a:off x="3919701" y="1154467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smtClean="0">
                <a:latin typeface="Calibri" pitchFamily="34" charset="0"/>
                <a:cs typeface="Calibri" pitchFamily="34" charset="0"/>
              </a:rPr>
              <a:t>*</a:t>
            </a:r>
            <a:endParaRPr lang="ko-KR" altLang="en-US" sz="1000" dirty="0"/>
          </a:p>
        </p:txBody>
      </p:sp>
      <p:sp>
        <p:nvSpPr>
          <p:cNvPr id="52" name="직사각형 51"/>
          <p:cNvSpPr/>
          <p:nvPr/>
        </p:nvSpPr>
        <p:spPr>
          <a:xfrm>
            <a:off x="4099929" y="1154467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smtClean="0">
                <a:latin typeface="Calibri" pitchFamily="34" charset="0"/>
                <a:cs typeface="Calibri" pitchFamily="34" charset="0"/>
              </a:rPr>
              <a:t>**</a:t>
            </a:r>
            <a:endParaRPr lang="ko-KR" altLang="en-US" sz="1000" dirty="0"/>
          </a:p>
        </p:txBody>
      </p:sp>
      <p:sp>
        <p:nvSpPr>
          <p:cNvPr id="53" name="직사각형 52"/>
          <p:cNvSpPr/>
          <p:nvPr/>
        </p:nvSpPr>
        <p:spPr>
          <a:xfrm>
            <a:off x="2611714" y="2428001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smtClean="0">
                <a:latin typeface="Calibri" pitchFamily="34" charset="0"/>
                <a:cs typeface="Calibri" pitchFamily="34" charset="0"/>
              </a:rPr>
              <a:t>*</a:t>
            </a:r>
            <a:endParaRPr lang="ko-KR" altLang="en-US" sz="1000" dirty="0"/>
          </a:p>
        </p:txBody>
      </p:sp>
      <p:sp>
        <p:nvSpPr>
          <p:cNvPr id="54" name="직사각형 53"/>
          <p:cNvSpPr/>
          <p:nvPr/>
        </p:nvSpPr>
        <p:spPr>
          <a:xfrm>
            <a:off x="2831698" y="2428001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smtClean="0">
                <a:latin typeface="Calibri" pitchFamily="34" charset="0"/>
                <a:cs typeface="Calibri" pitchFamily="34" charset="0"/>
              </a:rPr>
              <a:t>*</a:t>
            </a:r>
            <a:endParaRPr lang="ko-KR" altLang="en-US" sz="10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</Words>
  <Application>Microsoft Office PowerPoint</Application>
  <PresentationFormat>화면 슬라이드 쇼(4:3)</PresentationFormat>
  <Paragraphs>37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y</dc:creator>
  <cp:lastModifiedBy>y</cp:lastModifiedBy>
  <cp:revision>1</cp:revision>
  <dcterms:created xsi:type="dcterms:W3CDTF">2012-12-18T02:29:26Z</dcterms:created>
  <dcterms:modified xsi:type="dcterms:W3CDTF">2012-12-18T02:30:05Z</dcterms:modified>
</cp:coreProperties>
</file>